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908" y="148751"/>
            <a:ext cx="10461632" cy="7509831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284831" y="7784168"/>
            <a:ext cx="1162233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801688" indent="-801688"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clustering of expression profiles. Data are presented in a matrix format, in which each row represents an individual gene and each column represents a different tissue sample. Each cell in the matrix represents the expression level of a gene feature in an individual tissue sample. Red, high expression; green, low expression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 colon;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imary carcinoma; LM, liver metastases; NL, normal liver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0300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8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7:04Z</dcterms:modified>
</cp:coreProperties>
</file>